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9" descr="ALL THE HYPRPS (8)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666875" y="285750"/>
            <a:ext cx="5953125" cy="5734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76201" y="6096000"/>
            <a:ext cx="88392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Figure S4 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Comprehensive</a:t>
            </a:r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tree of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HyPRPs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Sorghum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Arabidopsis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Zea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Medicago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Horde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Beta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vulgaris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Setaria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kumimoji="0" lang="en-US" sz="11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Various </a:t>
            </a:r>
            <a:r>
              <a:rPr kumimoji="0" lang="en-US" sz="11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rops represented with different colors</a:t>
            </a:r>
            <a:endParaRPr kumimoji="0" lang="en-US" sz="180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3</cp:revision>
  <dcterms:created xsi:type="dcterms:W3CDTF">2006-08-16T00:00:00Z</dcterms:created>
  <dcterms:modified xsi:type="dcterms:W3CDTF">2022-08-06T06:57:35Z</dcterms:modified>
</cp:coreProperties>
</file>